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61" r:id="rId6"/>
    <p:sldId id="263" r:id="rId7"/>
    <p:sldId id="264" r:id="rId8"/>
    <p:sldId id="265" r:id="rId9"/>
    <p:sldId id="266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0962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437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898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8814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8662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102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0164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0969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5158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00358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9919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BA3F43-62A7-48FE-9BD2-974D40DECD6D}" type="datetimeFigureOut">
              <a:rPr lang="zh-CN" altLang="en-US" smtClean="0"/>
              <a:t>2022/5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E7CFEA-3943-45ED-BFD1-250B8E8D3A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4624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4" Type="http://schemas.openxmlformats.org/officeDocument/2006/relationships/image" Target="../media/image1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7" Type="http://schemas.openxmlformats.org/officeDocument/2006/relationships/image" Target="../media/image21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7" Type="http://schemas.openxmlformats.org/officeDocument/2006/relationships/image" Target="../media/image27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tiff"/><Relationship Id="rId5" Type="http://schemas.openxmlformats.org/officeDocument/2006/relationships/image" Target="../media/image25.tiff"/><Relationship Id="rId4" Type="http://schemas.openxmlformats.org/officeDocument/2006/relationships/image" Target="../media/image24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7" Type="http://schemas.openxmlformats.org/officeDocument/2006/relationships/image" Target="../media/image33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tiff"/><Relationship Id="rId5" Type="http://schemas.openxmlformats.org/officeDocument/2006/relationships/image" Target="../media/image31.tiff"/><Relationship Id="rId4" Type="http://schemas.openxmlformats.org/officeDocument/2006/relationships/image" Target="../media/image30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tiff"/><Relationship Id="rId7" Type="http://schemas.openxmlformats.org/officeDocument/2006/relationships/image" Target="../media/image39.tiff"/><Relationship Id="rId2" Type="http://schemas.openxmlformats.org/officeDocument/2006/relationships/image" Target="../media/image3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tiff"/><Relationship Id="rId5" Type="http://schemas.openxmlformats.org/officeDocument/2006/relationships/image" Target="../media/image37.tiff"/><Relationship Id="rId4" Type="http://schemas.openxmlformats.org/officeDocument/2006/relationships/image" Target="../media/image3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6740" y="738664"/>
            <a:ext cx="3924300" cy="3505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0" y="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. 2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262368" y="300078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21396" y="369332"/>
            <a:ext cx="40096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Marker  NC   SK4μM     6μM     8μM</a:t>
            </a:r>
            <a:endParaRPr lang="zh-CN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" y="71039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8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0" y="1015663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0" y="1420794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28240" y="1932140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28240" y="2443486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21881" y="2997484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7"/>
          <p:cNvSpPr txBox="1"/>
          <p:nvPr/>
        </p:nvSpPr>
        <p:spPr>
          <a:xfrm>
            <a:off x="4575354" y="2491264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6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13516" y="817132"/>
            <a:ext cx="3421956" cy="35976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文本框 16"/>
          <p:cNvSpPr txBox="1"/>
          <p:nvPr/>
        </p:nvSpPr>
        <p:spPr>
          <a:xfrm>
            <a:off x="5379985" y="71039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8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379984" y="1015663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379984" y="1420794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5508224" y="1932140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508224" y="2443486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501865" y="2912140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5535016" y="3522808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877417" y="486506"/>
            <a:ext cx="40096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Marker  NC  SK4μM  6μM    8μM</a:t>
            </a:r>
            <a:endParaRPr lang="zh-CN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7430833" y="3366816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7"/>
          <p:cNvSpPr txBox="1"/>
          <p:nvPr/>
        </p:nvSpPr>
        <p:spPr>
          <a:xfrm>
            <a:off x="9497251" y="2607398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94692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. 2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3462" y="738664"/>
            <a:ext cx="3038475" cy="36004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79983" y="738664"/>
            <a:ext cx="4743450" cy="37052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/>
          <p:cNvSpPr txBox="1"/>
          <p:nvPr/>
        </p:nvSpPr>
        <p:spPr>
          <a:xfrm>
            <a:off x="716886" y="369332"/>
            <a:ext cx="33886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Marker  NC   siRNA1 siRNA2</a:t>
            </a:r>
            <a:endParaRPr lang="zh-CN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5807046" y="369332"/>
            <a:ext cx="33886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Marker  NC   siRNA1 siRNA2</a:t>
            </a:r>
            <a:endParaRPr lang="zh-CN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" y="775240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8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0" y="1080506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0" y="1497829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28240" y="203355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28240" y="2544905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93043" y="3159863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28240" y="393774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956739" y="732568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8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956738" y="1037834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956738" y="145515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084978" y="199088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5084978" y="253880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049781" y="3190343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084978" y="3990235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852849" y="3025700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7"/>
          <p:cNvSpPr txBox="1"/>
          <p:nvPr/>
        </p:nvSpPr>
        <p:spPr>
          <a:xfrm>
            <a:off x="3736055" y="244764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6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7171224" y="3529195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7"/>
          <p:cNvSpPr txBox="1"/>
          <p:nvPr/>
        </p:nvSpPr>
        <p:spPr>
          <a:xfrm>
            <a:off x="9195660" y="2989568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59524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4493" y="685863"/>
            <a:ext cx="2619375" cy="4552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0" y="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. 4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15416" y="78676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8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15415" y="1092031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3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15415" y="1509354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43655" y="2118236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43655" y="2617390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26057" y="3457340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05066" y="4231862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844493" y="335438"/>
            <a:ext cx="2727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Marker      NC    SK 6μM</a:t>
            </a:r>
            <a:endParaRPr lang="zh-CN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108881" y="2986722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7"/>
          <p:cNvSpPr txBox="1"/>
          <p:nvPr/>
        </p:nvSpPr>
        <p:spPr>
          <a:xfrm>
            <a:off x="3378524" y="2432724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6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78367" y="704770"/>
            <a:ext cx="2455839" cy="29792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文本框 16"/>
          <p:cNvSpPr txBox="1"/>
          <p:nvPr/>
        </p:nvSpPr>
        <p:spPr>
          <a:xfrm>
            <a:off x="4742404" y="293147"/>
            <a:ext cx="2727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Marker   NC    SK 6μM</a:t>
            </a:r>
            <a:endParaRPr lang="zh-CN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256537" y="727996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237243" y="127669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220502" y="1843753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256537" y="2593006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2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266716" y="3046245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5859366" y="3672906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7"/>
          <p:cNvSpPr txBox="1"/>
          <p:nvPr/>
        </p:nvSpPr>
        <p:spPr>
          <a:xfrm>
            <a:off x="7271233" y="2317095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28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接箭头连接符 25"/>
          <p:cNvCxnSpPr>
            <a:stCxn id="24" idx="1"/>
          </p:cNvCxnSpPr>
          <p:nvPr/>
        </p:nvCxnSpPr>
        <p:spPr>
          <a:xfrm flipH="1" flipV="1">
            <a:off x="7046976" y="2432724"/>
            <a:ext cx="224257" cy="6903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595404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0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S1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418859" y="3776836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MCT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916452" y="3828884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8736980" y="3530434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0969" y="991663"/>
            <a:ext cx="2028825" cy="27908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97387" y="1015834"/>
            <a:ext cx="2038350" cy="27908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88249" y="1015834"/>
            <a:ext cx="2200275" cy="2514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文本框 11"/>
          <p:cNvSpPr txBox="1"/>
          <p:nvPr/>
        </p:nvSpPr>
        <p:spPr>
          <a:xfrm>
            <a:off x="548356" y="622331"/>
            <a:ext cx="2727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Marker   NC    SK 6μM</a:t>
            </a:r>
            <a:endParaRPr lang="zh-CN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64755" y="1360995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64755" y="186014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64755" y="2298053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64754" y="2938173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64753" y="3375838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2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1295" y="1015834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764629" y="2243374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3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062522" y="624277"/>
            <a:ext cx="2727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Marker   NC    SK 6μM</a:t>
            </a:r>
            <a:endParaRPr lang="zh-CN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7897656" y="646502"/>
            <a:ext cx="2727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Marker   NC    SK 6μM</a:t>
            </a:r>
            <a:endParaRPr lang="zh-CN" alt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675559" y="138537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675559" y="1884533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3675559" y="232243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3675558" y="296255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3675557" y="3400222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2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562099" y="1040218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6272762" y="279314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0234249" y="2137771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7450929" y="140412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7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7450929" y="1903281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5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7450929" y="2341185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7450928" y="2981305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35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7337469" y="1058966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34518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708221" y="152382"/>
            <a:ext cx="918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NC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0" y="1521913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PKM2</a:t>
            </a:r>
            <a:endParaRPr lang="en-US" altLang="zh-CN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2085" y="3405351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DAPI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0" y="5288789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Merge</a:t>
            </a: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476" y="4662208"/>
            <a:ext cx="3224658" cy="16560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476" y="2772544"/>
            <a:ext cx="3224657" cy="1656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476" y="882880"/>
            <a:ext cx="3224657" cy="1656000"/>
          </a:xfrm>
          <a:prstGeom prst="rect">
            <a:avLst/>
          </a:prstGeom>
        </p:spPr>
      </p:pic>
      <p:sp>
        <p:nvSpPr>
          <p:cNvPr id="44" name="文本框 43"/>
          <p:cNvSpPr txBox="1"/>
          <p:nvPr/>
        </p:nvSpPr>
        <p:spPr>
          <a:xfrm>
            <a:off x="0" y="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. 4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1360298" y="512158"/>
            <a:ext cx="5614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100</a:t>
            </a:r>
            <a:r>
              <a:rPr lang="en-US" altLang="zh-CN" dirty="0">
                <a:latin typeface="Arial" panose="020B0604020202090204" pitchFamily="34" charset="0"/>
                <a:cs typeface="Arial" panose="020B0604020202090204" pitchFamily="34" charset="0"/>
              </a:rPr>
              <a:t>× </a:t>
            </a:r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(Original image)                           400×</a:t>
            </a:r>
          </a:p>
        </p:txBody>
      </p:sp>
      <p:pic>
        <p:nvPicPr>
          <p:cNvPr id="46" name="图片 4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1917" y="2772544"/>
            <a:ext cx="3080930" cy="1656000"/>
          </a:xfrm>
          <a:prstGeom prst="rect">
            <a:avLst/>
          </a:prstGeom>
        </p:spPr>
      </p:pic>
      <p:pic>
        <p:nvPicPr>
          <p:cNvPr id="47" name="图片 4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7938" y="878579"/>
            <a:ext cx="3055256" cy="1656000"/>
          </a:xfrm>
          <a:prstGeom prst="rect">
            <a:avLst/>
          </a:prstGeom>
        </p:spPr>
      </p:pic>
      <p:pic>
        <p:nvPicPr>
          <p:cNvPr id="48" name="图片 4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7938" y="4662208"/>
            <a:ext cx="3099362" cy="16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54456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968306" y="89527"/>
            <a:ext cx="2639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Arial" panose="020B0604020202090204" pitchFamily="34" charset="0"/>
                <a:cs typeface="Arial" panose="020B0604020202090204" pitchFamily="34" charset="0"/>
              </a:rPr>
              <a:t>Shikonin</a:t>
            </a:r>
            <a:r>
              <a:rPr lang="en-US" altLang="zh-CN" dirty="0">
                <a:latin typeface="Arial" panose="020B0604020202090204" pitchFamily="34" charset="0"/>
                <a:cs typeface="Arial" panose="020B0604020202090204" pitchFamily="34" charset="0"/>
              </a:rPr>
              <a:t> 0.5mg/kg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0" y="1521913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PKM2</a:t>
            </a:r>
            <a:endParaRPr lang="en-US" altLang="zh-CN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2085" y="3405351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DAPI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0" y="5288789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Merge</a:t>
            </a:r>
          </a:p>
        </p:txBody>
      </p:sp>
      <p:sp>
        <p:nvSpPr>
          <p:cNvPr id="44" name="文本框 43"/>
          <p:cNvSpPr txBox="1"/>
          <p:nvPr/>
        </p:nvSpPr>
        <p:spPr>
          <a:xfrm>
            <a:off x="0" y="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. 4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1360298" y="512158"/>
            <a:ext cx="5614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100</a:t>
            </a:r>
            <a:r>
              <a:rPr lang="en-US" altLang="zh-CN" dirty="0">
                <a:latin typeface="Arial" panose="020B0604020202090204" pitchFamily="34" charset="0"/>
                <a:cs typeface="Arial" panose="020B0604020202090204" pitchFamily="34" charset="0"/>
              </a:rPr>
              <a:t>× </a:t>
            </a:r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(Original image)                           400×</a:t>
            </a: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662" y="2762017"/>
            <a:ext cx="3224664" cy="16560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662" y="920090"/>
            <a:ext cx="3224664" cy="1656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459" y="4603944"/>
            <a:ext cx="3224664" cy="1656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7962" y="4599688"/>
            <a:ext cx="3080930" cy="165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7962" y="2762017"/>
            <a:ext cx="3080930" cy="1656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7962" y="934789"/>
            <a:ext cx="3080930" cy="16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62598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270147" y="75361"/>
            <a:ext cx="26393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>
                <a:latin typeface="Arial" panose="020B0604020202090204" pitchFamily="34" charset="0"/>
                <a:cs typeface="Arial" panose="020B0604020202090204" pitchFamily="34" charset="0"/>
              </a:rPr>
              <a:t>Shikonin</a:t>
            </a:r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 </a:t>
            </a:r>
            <a:r>
              <a:rPr lang="en-US" altLang="zh-CN" dirty="0">
                <a:latin typeface="Arial" panose="020B0604020202090204" pitchFamily="34" charset="0"/>
                <a:cs typeface="Arial" panose="020B0604020202090204" pitchFamily="34" charset="0"/>
              </a:rPr>
              <a:t>2mg/kg</a:t>
            </a:r>
          </a:p>
          <a:p>
            <a:endParaRPr lang="en-US" altLang="zh-CN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0" y="1521913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PKM2</a:t>
            </a:r>
            <a:endParaRPr lang="en-US" altLang="zh-CN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2085" y="3405351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DAPI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0" y="5288789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Merge</a:t>
            </a:r>
          </a:p>
        </p:txBody>
      </p:sp>
      <p:sp>
        <p:nvSpPr>
          <p:cNvPr id="44" name="文本框 43"/>
          <p:cNvSpPr txBox="1"/>
          <p:nvPr/>
        </p:nvSpPr>
        <p:spPr>
          <a:xfrm>
            <a:off x="0" y="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. 4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1360298" y="512158"/>
            <a:ext cx="5614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100</a:t>
            </a:r>
            <a:r>
              <a:rPr lang="en-US" altLang="zh-CN" dirty="0">
                <a:latin typeface="Arial" panose="020B0604020202090204" pitchFamily="34" charset="0"/>
                <a:cs typeface="Arial" panose="020B0604020202090204" pitchFamily="34" charset="0"/>
              </a:rPr>
              <a:t>× </a:t>
            </a:r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(Original image)                           400×</a:t>
            </a: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459" y="2762017"/>
            <a:ext cx="3224664" cy="1656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459" y="878579"/>
            <a:ext cx="3224664" cy="1656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459" y="4645455"/>
            <a:ext cx="3224664" cy="1656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8781" y="878579"/>
            <a:ext cx="3080930" cy="1656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8781" y="4645455"/>
            <a:ext cx="3080930" cy="1656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8781" y="2762017"/>
            <a:ext cx="3080930" cy="16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54804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968306" y="89527"/>
            <a:ext cx="2639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90204" pitchFamily="34" charset="0"/>
                <a:cs typeface="Arial" panose="020B0604020202090204" pitchFamily="34" charset="0"/>
              </a:rPr>
              <a:t>Cisplatin 3mg/kg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0" y="1521913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PKM2</a:t>
            </a:r>
            <a:endParaRPr lang="en-US" altLang="zh-CN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2085" y="3405351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DAPI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0" y="5288789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Merge</a:t>
            </a:r>
          </a:p>
        </p:txBody>
      </p:sp>
      <p:sp>
        <p:nvSpPr>
          <p:cNvPr id="44" name="文本框 43"/>
          <p:cNvSpPr txBox="1"/>
          <p:nvPr/>
        </p:nvSpPr>
        <p:spPr>
          <a:xfrm>
            <a:off x="0" y="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. 4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1360298" y="512158"/>
            <a:ext cx="5614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100</a:t>
            </a:r>
            <a:r>
              <a:rPr lang="en-US" altLang="zh-CN" dirty="0">
                <a:latin typeface="Arial" panose="020B0604020202090204" pitchFamily="34" charset="0"/>
                <a:cs typeface="Arial" panose="020B0604020202090204" pitchFamily="34" charset="0"/>
              </a:rPr>
              <a:t>× </a:t>
            </a:r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(Original image)                           400×</a:t>
            </a: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662" y="934789"/>
            <a:ext cx="3224664" cy="1656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662" y="4645455"/>
            <a:ext cx="3224664" cy="1656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662" y="2762017"/>
            <a:ext cx="3224664" cy="1656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7962" y="2762017"/>
            <a:ext cx="3080930" cy="165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7962" y="934789"/>
            <a:ext cx="3080930" cy="1656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7962" y="4669786"/>
            <a:ext cx="3080930" cy="16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59449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968306" y="89527"/>
            <a:ext cx="26393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Arial" panose="020B0604020202090204" pitchFamily="34" charset="0"/>
                <a:cs typeface="Arial" panose="020B0604020202090204" pitchFamily="34" charset="0"/>
              </a:rPr>
              <a:t>Shikonin</a:t>
            </a:r>
            <a:r>
              <a:rPr lang="en-US" altLang="zh-CN" dirty="0">
                <a:latin typeface="Arial" panose="020B0604020202090204" pitchFamily="34" charset="0"/>
                <a:cs typeface="Arial" panose="020B0604020202090204" pitchFamily="34" charset="0"/>
              </a:rPr>
              <a:t> 0.5mg/kg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0" y="1521913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PKM2</a:t>
            </a:r>
            <a:endParaRPr lang="en-US" altLang="zh-CN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2085" y="3405351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DAPI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0" y="5288789"/>
            <a:ext cx="864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Merge</a:t>
            </a:r>
          </a:p>
        </p:txBody>
      </p:sp>
      <p:sp>
        <p:nvSpPr>
          <p:cNvPr id="44" name="文本框 43"/>
          <p:cNvSpPr txBox="1"/>
          <p:nvPr/>
        </p:nvSpPr>
        <p:spPr>
          <a:xfrm>
            <a:off x="0" y="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. 4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1360298" y="512158"/>
            <a:ext cx="5614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100</a:t>
            </a:r>
            <a:r>
              <a:rPr lang="en-US" altLang="zh-CN" dirty="0">
                <a:latin typeface="Arial" panose="020B0604020202090204" pitchFamily="34" charset="0"/>
                <a:cs typeface="Arial" panose="020B0604020202090204" pitchFamily="34" charset="0"/>
              </a:rPr>
              <a:t>× </a:t>
            </a:r>
            <a:r>
              <a:rPr lang="en-US" altLang="zh-CN" dirty="0" smtClean="0">
                <a:latin typeface="Arial" panose="020B0604020202090204" pitchFamily="34" charset="0"/>
                <a:cs typeface="Arial" panose="020B0604020202090204" pitchFamily="34" charset="0"/>
              </a:rPr>
              <a:t>(Original image)                           400×</a:t>
            </a: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705" y="2762017"/>
            <a:ext cx="3224664" cy="1656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705" y="4645455"/>
            <a:ext cx="3224664" cy="1656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8459" y="934789"/>
            <a:ext cx="3224664" cy="1656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2426" y="934789"/>
            <a:ext cx="3106605" cy="1656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2426" y="2762017"/>
            <a:ext cx="3080930" cy="1656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2426" y="4647477"/>
            <a:ext cx="3080930" cy="16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0657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206</Words>
  <Application>Microsoft Office PowerPoint</Application>
  <PresentationFormat>宽屏</PresentationFormat>
  <Paragraphs>117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P R 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Y</dc:creator>
  <cp:lastModifiedBy>HY</cp:lastModifiedBy>
  <cp:revision>48</cp:revision>
  <dcterms:created xsi:type="dcterms:W3CDTF">2022-05-23T08:04:30Z</dcterms:created>
  <dcterms:modified xsi:type="dcterms:W3CDTF">2022-05-24T03:52:03Z</dcterms:modified>
</cp:coreProperties>
</file>